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6"/>
  </p:notesMasterIdLst>
  <p:sldIdLst>
    <p:sldId id="264" r:id="rId2"/>
    <p:sldId id="267" r:id="rId3"/>
    <p:sldId id="276" r:id="rId4"/>
    <p:sldId id="278" r:id="rId5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3296810-A885-4BE3-A3E7-6D5BEEA58F35}" styleName="Style moyen 2 - Accentuation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>
    <p:restoredLeft sz="10550" autoAdjust="0"/>
    <p:restoredTop sz="95401" autoAdjust="0"/>
  </p:normalViewPr>
  <p:slideViewPr>
    <p:cSldViewPr>
      <p:cViewPr varScale="1">
        <p:scale>
          <a:sx n="69" d="100"/>
          <a:sy n="69" d="100"/>
        </p:scale>
        <p:origin x="1866" y="6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FDA8D1-9BF9-4368-8FC4-B440CA1F53FB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F8B289-3528-4D7D-A262-A3EDF6CB1123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2234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54C22-CC3D-428E-B8BF-89E34E00867D}" type="datetimeFigureOut">
              <a:rPr lang="fr-FR" smtClean="0"/>
              <a:pPr/>
              <a:t>08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6E94C-3E57-4F7C-AFE6-CBDECF154893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6615265"/>
              </p:ext>
            </p:extLst>
          </p:nvPr>
        </p:nvGraphicFramePr>
        <p:xfrm>
          <a:off x="251521" y="635724"/>
          <a:ext cx="8568952" cy="5529580"/>
        </p:xfrm>
        <a:graphic>
          <a:graphicData uri="http://schemas.openxmlformats.org/drawingml/2006/table">
            <a:tbl>
              <a:tblPr/>
              <a:tblGrid>
                <a:gridCol w="82774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15702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2228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6189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ene Name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Description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C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dj. p-value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TB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ymphotox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beta (TNF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uperfamily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mbe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3) (LTB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ranscrip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variant 1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,09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,60E-19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XCL1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hemokin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C-X-C motif) ligand 1 (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lanoma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rowth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imulating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tivity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, alpha) (CXCL1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,38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,34E-14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CL20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hemokin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C-C motif) ligand 20 (CCL20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ranscrip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variant 1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,15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,25E-1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RC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aculoviral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IAP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epea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ntaining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3 (BIRC3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ranscrip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variant 1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,0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,68E-1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L8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interleukin 8 (IL8), mRNA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,54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,00E-15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X3CL1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hemokin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C-X3-C motif) ligand 1 (CX3CL1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,30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,69E-17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AP1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transporter 1, ATP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nding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cassette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ub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amily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B (MDR/TAP) (TAP1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,82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,04E-1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ELB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v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el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eticuloendotheliosis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viral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oncogen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log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B (RELB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,72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,00E-15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UBD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ubiquit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D (UBD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,70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,63E-1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I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peptidase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nhibito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3, skin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erived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PI3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,46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,14E-1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LC3A1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olut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carrier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amily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3 (cystine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basic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and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utral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mino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id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ransporters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tivato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of cystine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basic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and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utral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mino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id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transport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mbe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1 (SLC3A1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,79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,55E-06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CL2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haet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cut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log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2 (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rosophila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) (ASCL2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,80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,85E-08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SCA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prostate stem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ell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ntige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PSCA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ranscrip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variant 1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,81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,000225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UCNR1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uccinat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ecepto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1 (SUCNR1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,85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,27E-05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EBPA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CCAAT/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nhance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nding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ote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C/EBP), alpha (CEBPA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,87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,31E-05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LITRK6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SLIT and NTRK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k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amily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mbe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6 (SLITRK6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,97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,97E-05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SL11A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RAS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k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amily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11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mbe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A (RASL11A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2,07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,0006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PINK5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serine peptidase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nhibito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Kazal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type 5 (SPINK5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ranscrip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variant 2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2,17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,60E-09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NC00261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long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ntergenic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non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ote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ding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RNA 261 (LINC00261), non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ding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RNA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2,20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,0001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R15L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omo sapiens proline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ich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15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k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PRR15L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2,53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,69E-11</a:t>
                      </a:r>
                    </a:p>
                  </a:txBody>
                  <a:tcPr marL="5030" marR="5030" marT="503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3" name="ZoneTexte 9">
            <a:extLst>
              <a:ext uri="{FF2B5EF4-FFF2-40B4-BE49-F238E27FC236}">
                <a16:creationId xmlns:a16="http://schemas.microsoft.com/office/drawing/2014/main" id="{F2C443EB-6EAB-3D42-A254-0FAEE80028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12360" y="6444044"/>
            <a:ext cx="129614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able S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9"/>
          <p:cNvSpPr txBox="1">
            <a:spLocks noChangeArrowheads="1"/>
          </p:cNvSpPr>
          <p:nvPr/>
        </p:nvSpPr>
        <p:spPr bwMode="auto">
          <a:xfrm>
            <a:off x="7812360" y="6444044"/>
            <a:ext cx="129614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able S2</a:t>
            </a:r>
          </a:p>
        </p:txBody>
      </p:sp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260082"/>
              </p:ext>
            </p:extLst>
          </p:nvPr>
        </p:nvGraphicFramePr>
        <p:xfrm>
          <a:off x="251520" y="332656"/>
          <a:ext cx="8640960" cy="603171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7874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5299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0405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1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ene Nam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fr-FR" sz="1200" b="1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Descrip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1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F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1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dj. p-valu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1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Pathway</a:t>
                      </a:r>
                      <a:endParaRPr lang="fr-FR" sz="1200" b="1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DACT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dappe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ntagonis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of beta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aten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log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3 (Xenopu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laevis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) (DACT3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7,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7,32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Wnt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/JN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YPEL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yippe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lik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4 (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Drosophila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) (YPEL4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3,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4,08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ER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SNAI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nail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homolog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1 (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Drosophila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) (SNAI1)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RNA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3,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5,04E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ER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AP3K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toge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ctivated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prote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kinase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kinas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kinas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14 (MAP3K14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9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4,88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NF</a:t>
                      </a:r>
                      <a:r>
                        <a:rPr lang="el-G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κ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IL17R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interleukin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17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receptor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D (IL17RD)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RNA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9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3,13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DAAM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dishevelled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associated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activator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of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orphogenesis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1 (DAAM1)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RNA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9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35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Wnt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/JN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IKBIP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Homo sapiens IKBKB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interacting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protein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(IKBIP)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transcript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variant 2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RNA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8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3,96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NF</a:t>
                      </a:r>
                      <a:r>
                        <a:rPr lang="el-G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κ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p38</a:t>
                      </a:r>
                      <a:r>
                        <a:rPr lang="el-G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β</a:t>
                      </a:r>
                      <a:endParaRPr lang="fr-FR" sz="1200" b="0" i="0" u="none" strike="noStrike" kern="1200" dirty="0">
                        <a:solidFill>
                          <a:schemeClr val="tx1"/>
                        </a:solidFill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toge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ctivated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prote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kinase 11 (MAPK11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8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8,95E-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p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IL10R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nterleuk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10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ecepto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, alpha (IL10RA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transcrip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variant 1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7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7,08E-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AP3K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toge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ctivated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prote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kinase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kinas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kinas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3 (MAP3K3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transcrip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variant 1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5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7,9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ERK/NF</a:t>
                      </a:r>
                      <a:r>
                        <a:rPr lang="el-G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κ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IL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interleukin 8 (IL8), mRN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1,5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5,98E-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JUN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ju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B proto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oncogen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(JUNB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1,6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4,07E-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JN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AP3K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toge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ctivated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prote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kinase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kinas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kinas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4 (MAP3K4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transcrip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variant 1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1,6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33E-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JN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NFKB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uclea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factor of kappa light polypeptide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gene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enhance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in B-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ells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1 (NFKB1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transcrip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variant 1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2,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35E-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NF</a:t>
                      </a:r>
                      <a:r>
                        <a:rPr lang="el-G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κ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MMP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atrix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etallopeptidase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7 (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atrilysin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uterine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) (MMP7)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RNA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2,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9,96E-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TLR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toll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ike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receptor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4 (TLR4)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transcript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variant 1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RNA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2,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3,54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JNK/NF</a:t>
                      </a:r>
                      <a:r>
                        <a:rPr lang="el-G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κ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IFNGR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interferon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gamma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receptor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2 (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interferon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gamma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transducer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1) (IFNGR2)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RNA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2,5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1,88E-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FOSL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Homo sapiens FOS-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ike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antigen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1 (FOSL1)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RNA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2,5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2,36E-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JN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CEBP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Homo sapiens CCAAT/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enhancer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binding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protein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(C/EBP), delta (CEBPD),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mRNA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2,9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4,86E-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T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omo sapiens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lymphotox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beta (TNF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uperfamily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ember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3) (LTB)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transcrip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variant 1,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R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-4,7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9,85E-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/>
                        <a:ea typeface="+mn-ea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9"/>
          <p:cNvSpPr txBox="1">
            <a:spLocks noChangeArrowheads="1"/>
          </p:cNvSpPr>
          <p:nvPr/>
        </p:nvSpPr>
        <p:spPr bwMode="auto">
          <a:xfrm>
            <a:off x="7812360" y="6444044"/>
            <a:ext cx="129614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able S3</a:t>
            </a:r>
          </a:p>
        </p:txBody>
      </p:sp>
      <p:graphicFrame>
        <p:nvGraphicFramePr>
          <p:cNvPr id="5" name="Tableau 4">
            <a:extLst>
              <a:ext uri="{FF2B5EF4-FFF2-40B4-BE49-F238E27FC236}">
                <a16:creationId xmlns:a16="http://schemas.microsoft.com/office/drawing/2014/main" id="{B7EFA2DB-96F7-E848-9B6F-8A4BEF1581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8029331"/>
              </p:ext>
            </p:extLst>
          </p:nvPr>
        </p:nvGraphicFramePr>
        <p:xfrm>
          <a:off x="683567" y="1337597"/>
          <a:ext cx="7776865" cy="403561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9116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119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0021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97350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73173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400" b="1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ene identifier</a:t>
                      </a:r>
                    </a:p>
                  </a:txBody>
                  <a:tcPr marL="66675" marR="66675" marT="66675" marB="66675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400" b="1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Species</a:t>
                      </a:r>
                      <a:endParaRPr lang="fr-FR" sz="1400" b="1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6675" marR="66675" marT="66675" marB="66675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400" b="1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Forward</a:t>
                      </a:r>
                      <a:r>
                        <a:rPr lang="fr-FR" sz="1400" b="1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primer (5'-3')</a:t>
                      </a:r>
                    </a:p>
                  </a:txBody>
                  <a:tcPr marL="66675" marR="66675" marT="66675" marB="66675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400" b="1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Reverse primer (5'-3')</a:t>
                      </a:r>
                    </a:p>
                  </a:txBody>
                  <a:tcPr marL="66675" marR="66675" marT="66675" marB="66675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Dact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uman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RT</a:t>
                      </a:r>
                      <a:r>
                        <a:rPr lang="fr-FR" sz="1200" b="0" i="0" u="none" strike="noStrike" kern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2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qPCR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Primer</a:t>
                      </a:r>
                      <a:r>
                        <a:rPr lang="fr-FR" sz="1200" b="0" i="0" u="none" strike="noStrike" kern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kern="1200" baseline="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ssay</a:t>
                      </a:r>
                      <a:r>
                        <a:rPr lang="fr-FR" sz="1200" b="0" i="0" u="none" strike="noStrike" kern="1200" baseline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PPH12258B </a:t>
                      </a:r>
                      <a:r>
                        <a:rPr lang="fr-FR" sz="1200" b="0" i="0" u="none" strike="noStrike" kern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(</a:t>
                      </a:r>
                      <a:r>
                        <a:rPr lang="fr-FR" sz="1200" b="0" i="0" u="none" strike="noStrike" kern="1200" baseline="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Qiagen</a:t>
                      </a:r>
                      <a:r>
                        <a:rPr lang="fr-FR" sz="1200" b="0" i="0" u="none" strike="noStrike" kern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, France)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NFKB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uman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CAGATGGCCCATACCTTC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TGCTGGTCCCACATAGTTGC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JNK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uman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TCTGGTATGATCCTTCTGAAGC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TCCTCCAAGTCCATAACTTCCT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-Ju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uman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TGCCGAAAAAGGAAGCTG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TGCGTTAGCATGAGTTGGC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JunB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uman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TCACCGAGGAGCAGGAG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TCTTGTGCAGATCGTCCAGG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-Fo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uman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TGTCTGTGGCTTCCCTTGATCTG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TGGATGATGCTGGGAACAGGAAG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IL-1</a:t>
                      </a:r>
                      <a:r>
                        <a:rPr lang="el-G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β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uman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AGAGAGTCCTGTGCTGAAT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TAGGAGAGGTCAGAGAGGC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IL-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uman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GTGCAGTTTTGCCAAGGA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TTCCTTGGGGTCCAGACAGA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B2M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uman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GATGAGTATGCCTGCCGT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TCATCCAATCCAAATGCGGC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Dact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Mouse</a:t>
                      </a:r>
                    </a:p>
                  </a:txBody>
                  <a:tcPr marL="9525" marR="9525" marT="9525" marB="0" anchor="ctr"/>
                </a:tc>
                <a:tc gridSpan="2"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RT</a:t>
                      </a:r>
                      <a:r>
                        <a:rPr lang="fr-FR" sz="1200" b="0" i="0" u="none" strike="noStrike" kern="1200" baseline="30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2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kern="12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qPCR</a:t>
                      </a: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Primer</a:t>
                      </a:r>
                      <a:r>
                        <a:rPr lang="fr-FR" sz="1200" b="0" i="0" u="none" strike="noStrike" kern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fr-FR" sz="1200" b="0" i="0" u="none" strike="noStrike" kern="1200" baseline="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ssay</a:t>
                      </a:r>
                      <a:r>
                        <a:rPr lang="fr-FR" sz="1200" b="0" i="0" u="none" strike="noStrike" kern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PPM29054A (</a:t>
                      </a:r>
                      <a:r>
                        <a:rPr lang="fr-FR" sz="1200" b="0" i="0" u="none" strike="noStrike" kern="1200" baseline="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Qiagen</a:t>
                      </a:r>
                      <a:r>
                        <a:rPr lang="fr-FR" sz="1200" b="0" i="0" u="none" strike="noStrike" kern="1200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, France)</a:t>
                      </a:r>
                      <a:endParaRPr lang="fr-FR" sz="1200" b="0" i="0" u="none" strike="noStrike" kern="1200" dirty="0">
                        <a:solidFill>
                          <a:srgbClr val="000000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1595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HMBS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Mous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TGGGCTCCTCTTGGAAT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ATGGGCAACTGTACCTGACTG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75586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9">
            <a:extLst>
              <a:ext uri="{FF2B5EF4-FFF2-40B4-BE49-F238E27FC236}">
                <a16:creationId xmlns:a16="http://schemas.microsoft.com/office/drawing/2014/main" id="{3FB22304-0F28-024E-B9DE-EA168C7350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12360" y="6444044"/>
            <a:ext cx="129614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able S4</a:t>
            </a:r>
          </a:p>
        </p:txBody>
      </p:sp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E7BEE3FA-BF36-1540-A04F-9EA98D5319E1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187624" y="2420888"/>
          <a:ext cx="6696744" cy="1785799"/>
        </p:xfrm>
        <a:graphic>
          <a:graphicData uri="http://schemas.openxmlformats.org/drawingml/2006/table">
            <a:tbl>
              <a:tblPr/>
              <a:tblGrid>
                <a:gridCol w="176023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5553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3253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0137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9154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5553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7363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>
                          <a:effectLst/>
                          <a:latin typeface="Verdana" charset="0"/>
                        </a:rPr>
                        <a:t>Sample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>
                          <a:effectLst/>
                          <a:latin typeface="Verdana" charset="0"/>
                        </a:rPr>
                        <a:t>[acetate]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>
                          <a:effectLst/>
                          <a:latin typeface="Verdana" charset="0"/>
                        </a:rPr>
                        <a:t>[propionate]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>
                          <a:effectLst/>
                          <a:latin typeface="Verdana" charset="0"/>
                        </a:rPr>
                        <a:t>[isobutyrate]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>
                          <a:effectLst/>
                          <a:latin typeface="Verdana" charset="0"/>
                        </a:rPr>
                        <a:t>[butyrate]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>
                          <a:effectLst/>
                          <a:latin typeface="Verdana" charset="0"/>
                        </a:rPr>
                        <a:t>[valerate]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7221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effectLst/>
                          <a:latin typeface="Verdana" charset="0"/>
                        </a:rPr>
                        <a:t>Butyrate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b="0" i="0" u="none" strike="noStrike">
                          <a:effectLst/>
                          <a:latin typeface="Verdana" charset="0"/>
                        </a:rPr>
                        <a:t>5,34 m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 charset="0"/>
                        </a:rPr>
                        <a:t>110,07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>
                          <a:effectLst/>
                          <a:latin typeface="Verdana" charset="0"/>
                        </a:rPr>
                        <a:t>3,77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10,59 </a:t>
                      </a:r>
                      <a:r>
                        <a:rPr lang="fi-FI" sz="10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mM</a:t>
                      </a:r>
                      <a:endParaRPr lang="fi-FI" sz="1000" b="1" i="0" u="none" strike="noStrike" dirty="0">
                        <a:solidFill>
                          <a:schemeClr val="tx1"/>
                        </a:solidFill>
                        <a:effectLst/>
                        <a:latin typeface="Verdana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effectLst/>
                          <a:latin typeface="Verdana" charset="0"/>
                        </a:rPr>
                        <a:t>4,66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7221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effectLst/>
                          <a:latin typeface="Verdana" charset="0"/>
                        </a:rPr>
                        <a:t>LYBHI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>
                          <a:effectLst/>
                          <a:latin typeface="Verdana" charset="0"/>
                        </a:rPr>
                        <a:t>4,55 m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>
                          <a:effectLst/>
                          <a:latin typeface="Verdana" charset="0"/>
                        </a:rPr>
                        <a:t>91,43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b="0" i="0" u="none" strike="noStrike">
                          <a:effectLst/>
                          <a:latin typeface="Verdana" charset="0"/>
                        </a:rPr>
                        <a:t>56,17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162,33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effectLst/>
                          <a:latin typeface="Verdana" charset="0"/>
                        </a:rPr>
                        <a:t>4,10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7221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effectLst/>
                          <a:latin typeface="Verdana" charset="0"/>
                        </a:rPr>
                        <a:t>MRS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effectLst/>
                          <a:latin typeface="Verdana" charset="0"/>
                        </a:rPr>
                        <a:t>76,67 m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>
                          <a:effectLst/>
                          <a:latin typeface="Verdana" charset="0"/>
                        </a:rPr>
                        <a:t>70,69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>
                          <a:effectLst/>
                          <a:latin typeface="Verdana" charset="0"/>
                        </a:rPr>
                        <a:t>4,29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11,09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b="0" i="0" u="none" strike="noStrike">
                          <a:effectLst/>
                          <a:latin typeface="Verdana" charset="0"/>
                        </a:rPr>
                        <a:t>8,41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7221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1" u="none" strike="noStrike" dirty="0">
                          <a:effectLst/>
                          <a:latin typeface="Verdana" charset="0"/>
                        </a:rPr>
                        <a:t>F. </a:t>
                      </a:r>
                      <a:r>
                        <a:rPr lang="fr-FR" sz="1000" b="0" i="1" u="none" strike="noStrike" dirty="0" err="1">
                          <a:effectLst/>
                          <a:latin typeface="Verdana" charset="0"/>
                        </a:rPr>
                        <a:t>prausnitzii</a:t>
                      </a:r>
                      <a:r>
                        <a:rPr lang="fr-FR" sz="1000" b="0" i="1" u="none" strike="noStrike" dirty="0">
                          <a:effectLst/>
                          <a:latin typeface="Verdana" charset="0"/>
                        </a:rPr>
                        <a:t> </a:t>
                      </a:r>
                      <a:r>
                        <a:rPr lang="fr-FR" sz="1000" b="0" i="0" u="none" strike="noStrike" dirty="0">
                          <a:effectLst/>
                          <a:latin typeface="Verdana" charset="0"/>
                        </a:rPr>
                        <a:t>A2-165 S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b="0" i="0" u="none" strike="noStrike">
                          <a:effectLst/>
                          <a:latin typeface="Verdana" charset="0"/>
                        </a:rPr>
                        <a:t>0,51 m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 charset="0"/>
                        </a:rPr>
                        <a:t>130,03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>
                          <a:effectLst/>
                          <a:latin typeface="Verdana" charset="0"/>
                        </a:rPr>
                        <a:t>2,80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11,85 </a:t>
                      </a:r>
                      <a:r>
                        <a:rPr lang="cs-CZ" sz="10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mM</a:t>
                      </a:r>
                      <a:endParaRPr lang="cs-CZ" sz="1000" b="1" i="0" u="none" strike="noStrike" dirty="0">
                        <a:solidFill>
                          <a:schemeClr val="tx1"/>
                        </a:solidFill>
                        <a:effectLst/>
                        <a:latin typeface="Verdana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effectLst/>
                          <a:latin typeface="Verdana" charset="0"/>
                        </a:rPr>
                        <a:t>12,66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7221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1" u="none" strike="noStrike" dirty="0">
                          <a:effectLst/>
                          <a:latin typeface="Verdana" charset="0"/>
                        </a:rPr>
                        <a:t>R. </a:t>
                      </a:r>
                      <a:r>
                        <a:rPr lang="fr-FR" sz="1000" b="0" i="1" u="none" strike="noStrike" dirty="0" err="1">
                          <a:effectLst/>
                          <a:latin typeface="Verdana" charset="0"/>
                        </a:rPr>
                        <a:t>intestinalis</a:t>
                      </a:r>
                      <a:r>
                        <a:rPr lang="fr-FR" sz="1000" b="0" i="1" u="none" strike="noStrike" dirty="0">
                          <a:effectLst/>
                          <a:latin typeface="Verdana" charset="0"/>
                        </a:rPr>
                        <a:t> </a:t>
                      </a:r>
                      <a:r>
                        <a:rPr lang="fr-FR" sz="1000" b="0" i="0" u="none" strike="noStrike" dirty="0">
                          <a:effectLst/>
                          <a:latin typeface="Verdana" charset="0"/>
                        </a:rPr>
                        <a:t>S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effectLst/>
                          <a:latin typeface="Verdana" charset="0"/>
                        </a:rPr>
                        <a:t>1,08 m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effectLst/>
                          <a:latin typeface="Verdana" charset="0"/>
                        </a:rPr>
                        <a:t>193,87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effectLst/>
                          <a:latin typeface="Verdana" charset="0"/>
                        </a:rPr>
                        <a:t>2,32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17,56 </a:t>
                      </a:r>
                      <a:r>
                        <a:rPr lang="nl-NL" sz="10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mM</a:t>
                      </a:r>
                      <a:endParaRPr lang="nl-NL" sz="1000" b="1" i="0" u="none" strike="noStrike" dirty="0">
                        <a:solidFill>
                          <a:schemeClr val="tx1"/>
                        </a:solidFill>
                        <a:effectLst/>
                        <a:latin typeface="Verdana" charset="0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 dirty="0">
                          <a:effectLst/>
                          <a:latin typeface="Verdana" charset="0"/>
                        </a:rPr>
                        <a:t>25,36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7221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1" u="none" strike="noStrike" dirty="0">
                          <a:effectLst/>
                          <a:latin typeface="Verdana" charset="0"/>
                        </a:rPr>
                        <a:t>A. </a:t>
                      </a:r>
                      <a:r>
                        <a:rPr lang="fr-FR" sz="1000" b="0" i="1" u="none" strike="noStrike" dirty="0" err="1">
                          <a:effectLst/>
                          <a:latin typeface="Verdana" charset="0"/>
                        </a:rPr>
                        <a:t>muciniphila</a:t>
                      </a:r>
                      <a:r>
                        <a:rPr lang="fr-FR" sz="1000" b="0" i="1" u="none" strike="noStrike" dirty="0">
                          <a:effectLst/>
                          <a:latin typeface="Verdana" charset="0"/>
                        </a:rPr>
                        <a:t> </a:t>
                      </a:r>
                      <a:r>
                        <a:rPr lang="fr-FR" sz="1000" b="0" i="0" u="none" strike="noStrike" dirty="0">
                          <a:effectLst/>
                          <a:latin typeface="Verdana" charset="0"/>
                        </a:rPr>
                        <a:t>S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effectLst/>
                          <a:latin typeface="Verdana" charset="0"/>
                        </a:rPr>
                        <a:t>8,68 m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effectLst/>
                          <a:latin typeface="Verdana" charset="0"/>
                        </a:rPr>
                        <a:t>193,82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effectLst/>
                          <a:latin typeface="Verdana" charset="0"/>
                        </a:rPr>
                        <a:t>101,40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130,30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b="0" i="0" u="none" strike="noStrike" dirty="0">
                          <a:effectLst/>
                          <a:latin typeface="Verdana" charset="0"/>
                        </a:rPr>
                        <a:t>5,36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7221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1" u="none" strike="noStrike" dirty="0">
                          <a:effectLst/>
                          <a:latin typeface="Verdana" charset="0"/>
                        </a:rPr>
                        <a:t>B. </a:t>
                      </a:r>
                      <a:r>
                        <a:rPr lang="fr-FR" sz="1000" b="0" i="1" u="none" strike="noStrike" dirty="0" err="1">
                          <a:effectLst/>
                          <a:latin typeface="Verdana" charset="0"/>
                        </a:rPr>
                        <a:t>thetaiotaomicron</a:t>
                      </a:r>
                      <a:r>
                        <a:rPr lang="fr-FR" sz="1000" b="0" i="0" u="none" strike="noStrike" dirty="0">
                          <a:effectLst/>
                          <a:latin typeface="Verdana" charset="0"/>
                        </a:rPr>
                        <a:t> S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>
                          <a:effectLst/>
                          <a:latin typeface="Verdana" charset="0"/>
                        </a:rPr>
                        <a:t>8,96 m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effectLst/>
                          <a:latin typeface="Verdana" charset="0"/>
                        </a:rPr>
                        <a:t>282,10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>
                          <a:effectLst/>
                          <a:latin typeface="Verdana" charset="0"/>
                        </a:rPr>
                        <a:t>69,47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119,07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>
                          <a:effectLst/>
                          <a:latin typeface="Verdana" charset="0"/>
                        </a:rPr>
                        <a:t>4,74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1622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1" u="none" strike="noStrike" dirty="0">
                          <a:effectLst/>
                          <a:latin typeface="Verdana" charset="0"/>
                        </a:rPr>
                        <a:t>L </a:t>
                      </a:r>
                      <a:r>
                        <a:rPr lang="fr-FR" sz="1000" b="0" i="1" u="none" strike="noStrike" dirty="0" err="1">
                          <a:effectLst/>
                          <a:latin typeface="Verdana" charset="0"/>
                        </a:rPr>
                        <a:t>casei</a:t>
                      </a:r>
                      <a:r>
                        <a:rPr lang="fr-FR" sz="1000" b="0" i="1" u="none" strike="noStrike" dirty="0">
                          <a:effectLst/>
                          <a:latin typeface="Verdana" charset="0"/>
                        </a:rPr>
                        <a:t> </a:t>
                      </a:r>
                      <a:r>
                        <a:rPr lang="fr-FR" sz="1000" b="0" i="0" u="none" strike="noStrike" dirty="0">
                          <a:effectLst/>
                          <a:latin typeface="Verdana" charset="0"/>
                        </a:rPr>
                        <a:t>BL-23 S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effectLst/>
                          <a:latin typeface="Verdana" charset="0"/>
                        </a:rPr>
                        <a:t>80,05 m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effectLst/>
                          <a:latin typeface="Verdana" charset="0"/>
                        </a:rPr>
                        <a:t>82,67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effectLst/>
                          <a:latin typeface="Verdana" charset="0"/>
                        </a:rPr>
                        <a:t>5,48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Verdana" charset="0"/>
                        </a:rPr>
                        <a:t>14,46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b="0" i="0" u="none" strike="noStrike" dirty="0">
                          <a:effectLst/>
                          <a:latin typeface="Verdana" charset="0"/>
                        </a:rPr>
                        <a:t>8,39 µM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450383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21</TotalTime>
  <Words>941</Words>
  <Application>Microsoft Office PowerPoint</Application>
  <PresentationFormat>On-screen Show (4:3)</PresentationFormat>
  <Paragraphs>28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Times New Roman</vt:lpstr>
      <vt:lpstr>Verdana</vt:lpstr>
      <vt:lpstr>Thème Offic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rion Lenoir</dc:creator>
  <cp:lastModifiedBy>Usha Thangaraj, Integra-PDY, IN</cp:lastModifiedBy>
  <cp:revision>336</cp:revision>
  <dcterms:created xsi:type="dcterms:W3CDTF">2014-06-23T15:00:03Z</dcterms:created>
  <dcterms:modified xsi:type="dcterms:W3CDTF">2020-10-07T21:12:31Z</dcterms:modified>
</cp:coreProperties>
</file>